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70177-9F62-4BE1-86B9-65E077EAB6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5B2F0-BDA6-4CD0-BDE3-B8DCDDC35C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B0A70-640C-4D59-951C-6BF2CB1345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F4371-B209-42E0-A000-E10DF548A3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AE7B05-A359-4F24-A572-B6AC02C94B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F30C7-F8FD-41EA-A394-2AC6D8B9F9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3D6E8-E622-4D1A-A8A6-A5A03DABE9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0902F-2A5A-4291-AFA6-206D0B2F6D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67433-8D53-4227-B996-ACB93A8F7C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A24DE-0142-4443-9A4E-83B5A19274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5554B-A507-4E2A-9B31-14DE17D57A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81FD7-F034-4CC7-9F10-B553E2A6A9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B7B823-BFDF-4DF9-B54C-D4D08767A21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23541" b="0"/>
          <a:stretch/>
        </p:blipFill>
        <p:spPr>
          <a:xfrm>
            <a:off x="4859280" y="3716280"/>
            <a:ext cx="1297080" cy="158436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22606" b="0"/>
          <a:stretch/>
        </p:blipFill>
        <p:spPr>
          <a:xfrm>
            <a:off x="898560" y="1506600"/>
            <a:ext cx="1320840" cy="15606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rcRect l="0" t="0" r="22606" b="0"/>
          <a:stretch/>
        </p:blipFill>
        <p:spPr>
          <a:xfrm>
            <a:off x="2219400" y="1506600"/>
            <a:ext cx="1320840" cy="15606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rcRect l="0" t="0" r="22606" b="0"/>
          <a:stretch/>
        </p:blipFill>
        <p:spPr>
          <a:xfrm>
            <a:off x="3538440" y="1506600"/>
            <a:ext cx="1319400" cy="156204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rcRect l="0" t="0" r="23541" b="0"/>
          <a:stretch/>
        </p:blipFill>
        <p:spPr>
          <a:xfrm>
            <a:off x="4861080" y="1506600"/>
            <a:ext cx="1317600" cy="157788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6"/>
          <a:srcRect l="0" t="0" r="23541" b="0"/>
          <a:stretch/>
        </p:blipFill>
        <p:spPr>
          <a:xfrm>
            <a:off x="6178680" y="1506600"/>
            <a:ext cx="1320840" cy="157968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7"/>
          <a:srcRect l="0" t="0" r="23541" b="0"/>
          <a:stretch/>
        </p:blipFill>
        <p:spPr>
          <a:xfrm>
            <a:off x="7499520" y="1506600"/>
            <a:ext cx="1320480" cy="157968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8"/>
          <a:srcRect l="0" t="0" r="23541" b="0"/>
          <a:stretch/>
        </p:blipFill>
        <p:spPr>
          <a:xfrm>
            <a:off x="898560" y="3728880"/>
            <a:ext cx="1312920" cy="15717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9"/>
          <a:srcRect l="0" t="0" r="23541" b="0"/>
          <a:stretch/>
        </p:blipFill>
        <p:spPr>
          <a:xfrm>
            <a:off x="2219400" y="3720960"/>
            <a:ext cx="1320840" cy="157968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10"/>
          <a:srcRect l="0" t="0" r="23541" b="0"/>
          <a:stretch/>
        </p:blipFill>
        <p:spPr>
          <a:xfrm>
            <a:off x="3505320" y="3733920"/>
            <a:ext cx="1320840" cy="1579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11"/>
          <a:srcRect l="0" t="0" r="23541" b="0"/>
          <a:stretch/>
        </p:blipFill>
        <p:spPr>
          <a:xfrm>
            <a:off x="6178680" y="3722760"/>
            <a:ext cx="1319040" cy="157788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12"/>
          <a:srcRect l="0" t="0" r="22606" b="0"/>
          <a:stretch/>
        </p:blipFill>
        <p:spPr>
          <a:xfrm>
            <a:off x="7499520" y="3689280"/>
            <a:ext cx="1320480" cy="1611360"/>
          </a:xfrm>
          <a:prstGeom prst="rect">
            <a:avLst/>
          </a:prstGeom>
          <a:ln w="0">
            <a:noFill/>
          </a:ln>
        </p:spPr>
      </p:pic>
      <p:sp>
        <p:nvSpPr>
          <p:cNvPr id="53" name="Text Box 81"/>
          <p:cNvSpPr/>
          <p:nvPr/>
        </p:nvSpPr>
        <p:spPr>
          <a:xfrm>
            <a:off x="1476360" y="165888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93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6.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0.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1"/>
          <p:cNvSpPr/>
          <p:nvPr/>
        </p:nvSpPr>
        <p:spPr>
          <a:xfrm>
            <a:off x="2841480" y="1628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19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8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81"/>
          <p:cNvSpPr/>
          <p:nvPr/>
        </p:nvSpPr>
        <p:spPr>
          <a:xfrm>
            <a:off x="4137120" y="165888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54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42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2.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81"/>
          <p:cNvSpPr/>
          <p:nvPr/>
        </p:nvSpPr>
        <p:spPr>
          <a:xfrm>
            <a:off x="5505480" y="1628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77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19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2.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81"/>
          <p:cNvSpPr/>
          <p:nvPr/>
        </p:nvSpPr>
        <p:spPr>
          <a:xfrm>
            <a:off x="6802560" y="1628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83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 9.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  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"/>
          <p:cNvSpPr/>
          <p:nvPr/>
        </p:nvSpPr>
        <p:spPr>
          <a:xfrm>
            <a:off x="1330200" y="120960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0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4"/>
          <p:cNvSpPr/>
          <p:nvPr/>
        </p:nvSpPr>
        <p:spPr>
          <a:xfrm>
            <a:off x="2770200" y="12096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"/>
          <p:cNvSpPr/>
          <p:nvPr/>
        </p:nvSpPr>
        <p:spPr>
          <a:xfrm>
            <a:off x="4065480" y="120960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6"/>
          <p:cNvSpPr/>
          <p:nvPr/>
        </p:nvSpPr>
        <p:spPr>
          <a:xfrm>
            <a:off x="5291280" y="11970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7"/>
          <p:cNvSpPr/>
          <p:nvPr/>
        </p:nvSpPr>
        <p:spPr>
          <a:xfrm>
            <a:off x="6586560" y="119700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"/>
          <p:cNvSpPr/>
          <p:nvPr/>
        </p:nvSpPr>
        <p:spPr>
          <a:xfrm>
            <a:off x="250920" y="2060640"/>
            <a:ext cx="57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tr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0"/>
          <p:cNvSpPr/>
          <p:nvPr/>
        </p:nvSpPr>
        <p:spPr>
          <a:xfrm>
            <a:off x="216000" y="4449600"/>
            <a:ext cx="68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l-sh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7"/>
          <p:cNvSpPr/>
          <p:nvPr/>
        </p:nvSpPr>
        <p:spPr>
          <a:xfrm>
            <a:off x="8026560" y="1197000"/>
            <a:ext cx="57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8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81"/>
          <p:cNvSpPr/>
          <p:nvPr/>
        </p:nvSpPr>
        <p:spPr>
          <a:xfrm>
            <a:off x="8026560" y="1628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78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15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6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81"/>
          <p:cNvSpPr/>
          <p:nvPr/>
        </p:nvSpPr>
        <p:spPr>
          <a:xfrm>
            <a:off x="1473120" y="389088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93.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5.7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0.5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81"/>
          <p:cNvSpPr/>
          <p:nvPr/>
        </p:nvSpPr>
        <p:spPr>
          <a:xfrm>
            <a:off x="2841480" y="3860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92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6.5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1.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81"/>
          <p:cNvSpPr/>
          <p:nvPr/>
        </p:nvSpPr>
        <p:spPr>
          <a:xfrm>
            <a:off x="4137120" y="389088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36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62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1.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81"/>
          <p:cNvSpPr/>
          <p:nvPr/>
        </p:nvSpPr>
        <p:spPr>
          <a:xfrm>
            <a:off x="5435640" y="3860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75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42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3.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81"/>
          <p:cNvSpPr/>
          <p:nvPr/>
        </p:nvSpPr>
        <p:spPr>
          <a:xfrm>
            <a:off x="6802560" y="3860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88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9.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2.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81"/>
          <p:cNvSpPr/>
          <p:nvPr/>
        </p:nvSpPr>
        <p:spPr>
          <a:xfrm>
            <a:off x="8026560" y="3860640"/>
            <a:ext cx="720720" cy="40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83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S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  12.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%G2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 3.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851280" y="26028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UNX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9080" y="5599080"/>
            <a:ext cx="87026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Figure S6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 ShRNA-mediated knockdown of the RUNX2 expression in SKOV3 cells: effect on cell cycle control. Cell cycle progression in the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Mincho"/>
              </a:rPr>
              <a:t>shRNA-RUNX2 clone 3  (cl-sh3) was compared to the mock-transfected control (ctrl) clone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4T21:32:24Z</dcterms:created>
  <dc:creator>Dbatch</dc:creator>
  <dc:description/>
  <dc:language>en-US</dc:language>
  <cp:lastModifiedBy>Dbatch</cp:lastModifiedBy>
  <dcterms:modified xsi:type="dcterms:W3CDTF">2013-09-10T16:32:52Z</dcterms:modified>
  <cp:revision>7</cp:revision>
  <dc:subject/>
  <dc:title>Diapositive 1</dc:title>
</cp:coreProperties>
</file>